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ahab Uddin Khan" initials="SUK" lastIdx="1" clrIdx="0">
    <p:extLst>
      <p:ext uri="{19B8F6BF-5375-455C-9EA6-DF929625EA0E}">
        <p15:presenceInfo xmlns:p15="http://schemas.microsoft.com/office/powerpoint/2012/main" userId="S::SKhan34@hamad.qa::094ee109-24ec-4415-adf4-f36efba4018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8536D34-E4E0-400F-9029-2204521AA67F}" v="48" dt="2022-08-12T10:57:13.52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695" autoAdjust="0"/>
    <p:restoredTop sz="87309" autoAdjust="0"/>
  </p:normalViewPr>
  <p:slideViewPr>
    <p:cSldViewPr snapToGrid="0">
      <p:cViewPr varScale="1">
        <p:scale>
          <a:sx n="75" d="100"/>
          <a:sy n="75" d="100"/>
        </p:scale>
        <p:origin x="144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bah Akhtar" userId="1c357625-e33f-447b-bc0a-de84de8ec01a" providerId="ADAL" clId="{58536D34-E4E0-400F-9029-2204521AA67F}"/>
    <pc:docChg chg="undo custSel modSld">
      <pc:chgData name="Sabah Akhtar" userId="1c357625-e33f-447b-bc0a-de84de8ec01a" providerId="ADAL" clId="{58536D34-E4E0-400F-9029-2204521AA67F}" dt="2022-08-12T10:57:32.999" v="186" actId="1076"/>
      <pc:docMkLst>
        <pc:docMk/>
      </pc:docMkLst>
      <pc:sldChg chg="addSp delSp modSp mod">
        <pc:chgData name="Sabah Akhtar" userId="1c357625-e33f-447b-bc0a-de84de8ec01a" providerId="ADAL" clId="{58536D34-E4E0-400F-9029-2204521AA67F}" dt="2022-08-12T10:57:32.999" v="186" actId="1076"/>
        <pc:sldMkLst>
          <pc:docMk/>
          <pc:sldMk cId="924461734" sldId="300"/>
        </pc:sldMkLst>
        <pc:spChg chg="add del mod">
          <ac:chgData name="Sabah Akhtar" userId="1c357625-e33f-447b-bc0a-de84de8ec01a" providerId="ADAL" clId="{58536D34-E4E0-400F-9029-2204521AA67F}" dt="2022-08-12T10:57:13.519" v="183"/>
          <ac:spMkLst>
            <pc:docMk/>
            <pc:sldMk cId="924461734" sldId="300"/>
            <ac:spMk id="4" creationId="{0B8135A0-56E7-A558-5766-C1D9310A0822}"/>
          </ac:spMkLst>
        </pc:spChg>
        <pc:spChg chg="add mod">
          <ac:chgData name="Sabah Akhtar" userId="1c357625-e33f-447b-bc0a-de84de8ec01a" providerId="ADAL" clId="{58536D34-E4E0-400F-9029-2204521AA67F}" dt="2022-08-12T10:57:32.999" v="186" actId="1076"/>
          <ac:spMkLst>
            <pc:docMk/>
            <pc:sldMk cId="924461734" sldId="300"/>
            <ac:spMk id="13" creationId="{35A3D724-1A3B-4E74-A98A-392E3AF9DD11}"/>
          </ac:spMkLst>
        </pc:spChg>
        <pc:spChg chg="add mod">
          <ac:chgData name="Sabah Akhtar" userId="1c357625-e33f-447b-bc0a-de84de8ec01a" providerId="ADAL" clId="{58536D34-E4E0-400F-9029-2204521AA67F}" dt="2022-08-12T10:57:32.999" v="186" actId="1076"/>
          <ac:spMkLst>
            <pc:docMk/>
            <pc:sldMk cId="924461734" sldId="300"/>
            <ac:spMk id="14" creationId="{EE04B4FE-831B-FFA6-0924-5F7D549B5274}"/>
          </ac:spMkLst>
        </pc:spChg>
        <pc:spChg chg="mod">
          <ac:chgData name="Sabah Akhtar" userId="1c357625-e33f-447b-bc0a-de84de8ec01a" providerId="ADAL" clId="{58536D34-E4E0-400F-9029-2204521AA67F}" dt="2022-07-30T11:26:21.648" v="49"/>
          <ac:spMkLst>
            <pc:docMk/>
            <pc:sldMk cId="924461734" sldId="300"/>
            <ac:spMk id="21" creationId="{7C939D84-D8AB-6977-0974-FC462D4C0D2C}"/>
          </ac:spMkLst>
        </pc:spChg>
        <pc:spChg chg="mod">
          <ac:chgData name="Sabah Akhtar" userId="1c357625-e33f-447b-bc0a-de84de8ec01a" providerId="ADAL" clId="{58536D34-E4E0-400F-9029-2204521AA67F}" dt="2022-07-30T11:26:21.648" v="49"/>
          <ac:spMkLst>
            <pc:docMk/>
            <pc:sldMk cId="924461734" sldId="300"/>
            <ac:spMk id="23" creationId="{EF19C357-40B4-EB7C-3F9B-4D30F603E747}"/>
          </ac:spMkLst>
        </pc:spChg>
        <pc:spChg chg="add mod">
          <ac:chgData name="Sabah Akhtar" userId="1c357625-e33f-447b-bc0a-de84de8ec01a" providerId="ADAL" clId="{58536D34-E4E0-400F-9029-2204521AA67F}" dt="2022-07-30T11:30:44.387" v="88" actId="1076"/>
          <ac:spMkLst>
            <pc:docMk/>
            <pc:sldMk cId="924461734" sldId="300"/>
            <ac:spMk id="24" creationId="{CD1353B6-47FE-4210-6405-28515BD88C94}"/>
          </ac:spMkLst>
        </pc:spChg>
        <pc:spChg chg="mod">
          <ac:chgData name="Sabah Akhtar" userId="1c357625-e33f-447b-bc0a-de84de8ec01a" providerId="ADAL" clId="{58536D34-E4E0-400F-9029-2204521AA67F}" dt="2022-07-17T17:39:31.551" v="9" actId="1076"/>
          <ac:spMkLst>
            <pc:docMk/>
            <pc:sldMk cId="924461734" sldId="300"/>
            <ac:spMk id="25" creationId="{1621E2DB-65D7-49EE-AA3B-94F6140F4611}"/>
          </ac:spMkLst>
        </pc:spChg>
        <pc:spChg chg="add mod">
          <ac:chgData name="Sabah Akhtar" userId="1c357625-e33f-447b-bc0a-de84de8ec01a" providerId="ADAL" clId="{58536D34-E4E0-400F-9029-2204521AA67F}" dt="2022-07-30T11:30:58.435" v="89" actId="1076"/>
          <ac:spMkLst>
            <pc:docMk/>
            <pc:sldMk cId="924461734" sldId="300"/>
            <ac:spMk id="26" creationId="{655BF694-1923-5250-B44A-8A3FC0E3AE37}"/>
          </ac:spMkLst>
        </pc:spChg>
        <pc:spChg chg="add mod">
          <ac:chgData name="Sabah Akhtar" userId="1c357625-e33f-447b-bc0a-de84de8ec01a" providerId="ADAL" clId="{58536D34-E4E0-400F-9029-2204521AA67F}" dt="2022-08-12T10:57:32.999" v="186" actId="1076"/>
          <ac:spMkLst>
            <pc:docMk/>
            <pc:sldMk cId="924461734" sldId="300"/>
            <ac:spMk id="27" creationId="{D616AE4A-B5FC-B89D-D074-29C86DC8454B}"/>
          </ac:spMkLst>
        </pc:spChg>
        <pc:spChg chg="del">
          <ac:chgData name="Sabah Akhtar" userId="1c357625-e33f-447b-bc0a-de84de8ec01a" providerId="ADAL" clId="{58536D34-E4E0-400F-9029-2204521AA67F}" dt="2022-07-30T11:26:38.996" v="52" actId="478"/>
          <ac:spMkLst>
            <pc:docMk/>
            <pc:sldMk cId="924461734" sldId="300"/>
            <ac:spMk id="47" creationId="{77AC2AFA-E8CE-4E8C-8B35-F5474E708250}"/>
          </ac:spMkLst>
        </pc:spChg>
        <pc:spChg chg="del">
          <ac:chgData name="Sabah Akhtar" userId="1c357625-e33f-447b-bc0a-de84de8ec01a" providerId="ADAL" clId="{58536D34-E4E0-400F-9029-2204521AA67F}" dt="2022-07-30T11:26:32.874" v="51" actId="478"/>
          <ac:spMkLst>
            <pc:docMk/>
            <pc:sldMk cId="924461734" sldId="300"/>
            <ac:spMk id="49" creationId="{0256123D-1F25-4DE1-B766-914CDDE79B8F}"/>
          </ac:spMkLst>
        </pc:spChg>
        <pc:spChg chg="mod">
          <ac:chgData name="Sabah Akhtar" userId="1c357625-e33f-447b-bc0a-de84de8ec01a" providerId="ADAL" clId="{58536D34-E4E0-400F-9029-2204521AA67F}" dt="2022-07-30T11:28:25.556" v="72" actId="1076"/>
          <ac:spMkLst>
            <pc:docMk/>
            <pc:sldMk cId="924461734" sldId="300"/>
            <ac:spMk id="51" creationId="{FCFF4B41-8708-4400-B3E2-C36C7948BDF1}"/>
          </ac:spMkLst>
        </pc:spChg>
        <pc:spChg chg="mod">
          <ac:chgData name="Sabah Akhtar" userId="1c357625-e33f-447b-bc0a-de84de8ec01a" providerId="ADAL" clId="{58536D34-E4E0-400F-9029-2204521AA67F}" dt="2022-07-30T11:28:22.215" v="71" actId="1076"/>
          <ac:spMkLst>
            <pc:docMk/>
            <pc:sldMk cId="924461734" sldId="300"/>
            <ac:spMk id="53" creationId="{9FAEB026-269D-4B2D-9340-ABB962B1B3F8}"/>
          </ac:spMkLst>
        </pc:spChg>
        <pc:grpChg chg="add mod">
          <ac:chgData name="Sabah Akhtar" userId="1c357625-e33f-447b-bc0a-de84de8ec01a" providerId="ADAL" clId="{58536D34-E4E0-400F-9029-2204521AA67F}" dt="2022-07-30T11:30:58.435" v="89" actId="1076"/>
          <ac:grpSpMkLst>
            <pc:docMk/>
            <pc:sldMk cId="924461734" sldId="300"/>
            <ac:grpSpMk id="20" creationId="{B30CCFE6-F38C-966C-FD24-F96B06BA52FC}"/>
          </ac:grpSpMkLst>
        </pc:grpChg>
        <pc:grpChg chg="del mod">
          <ac:chgData name="Sabah Akhtar" userId="1c357625-e33f-447b-bc0a-de84de8ec01a" providerId="ADAL" clId="{58536D34-E4E0-400F-9029-2204521AA67F}" dt="2022-07-30T11:26:43.391" v="53" actId="478"/>
          <ac:grpSpMkLst>
            <pc:docMk/>
            <pc:sldMk cId="924461734" sldId="300"/>
            <ac:grpSpMk id="45" creationId="{85AA01BC-5911-4F81-A0AD-2CC118B3ED52}"/>
          </ac:grpSpMkLst>
        </pc:grpChg>
        <pc:grpChg chg="mod topLvl">
          <ac:chgData name="Sabah Akhtar" userId="1c357625-e33f-447b-bc0a-de84de8ec01a" providerId="ADAL" clId="{58536D34-E4E0-400F-9029-2204521AA67F}" dt="2022-07-30T11:30:58.435" v="89" actId="1076"/>
          <ac:grpSpMkLst>
            <pc:docMk/>
            <pc:sldMk cId="924461734" sldId="300"/>
            <ac:grpSpMk id="46" creationId="{6762CF59-E5F7-4346-9238-726492E5747C}"/>
          </ac:grpSpMkLst>
        </pc:grpChg>
        <pc:graphicFrameChg chg="add del mod">
          <ac:chgData name="Sabah Akhtar" userId="1c357625-e33f-447b-bc0a-de84de8ec01a" providerId="ADAL" clId="{58536D34-E4E0-400F-9029-2204521AA67F}" dt="2022-08-07T17:43:43.530" v="102" actId="478"/>
          <ac:graphicFrameMkLst>
            <pc:docMk/>
            <pc:sldMk cId="924461734" sldId="300"/>
            <ac:graphicFrameMk id="12" creationId="{86D1E52D-20C4-E43E-30CC-5B4208B82726}"/>
          </ac:graphicFrameMkLst>
        </pc:graphicFrameChg>
        <pc:picChg chg="add del mod">
          <ac:chgData name="Sabah Akhtar" userId="1c357625-e33f-447b-bc0a-de84de8ec01a" providerId="ADAL" clId="{58536D34-E4E0-400F-9029-2204521AA67F}" dt="2022-08-12T10:57:19.721" v="185" actId="478"/>
          <ac:picMkLst>
            <pc:docMk/>
            <pc:sldMk cId="924461734" sldId="300"/>
            <ac:picMk id="3" creationId="{01AB0ABE-9DD6-355A-8A7B-1AA796718255}"/>
          </ac:picMkLst>
        </pc:picChg>
        <pc:picChg chg="add del mod modCrop">
          <ac:chgData name="Sabah Akhtar" userId="1c357625-e33f-447b-bc0a-de84de8ec01a" providerId="ADAL" clId="{58536D34-E4E0-400F-9029-2204521AA67F}" dt="2022-08-07T17:45:38.905" v="112" actId="478"/>
          <ac:picMkLst>
            <pc:docMk/>
            <pc:sldMk cId="924461734" sldId="300"/>
            <ac:picMk id="3" creationId="{20DD4001-E7AF-A455-BBAF-4AE7342540B2}"/>
          </ac:picMkLst>
        </pc:picChg>
        <pc:picChg chg="add del mod modCrop">
          <ac:chgData name="Sabah Akhtar" userId="1c357625-e33f-447b-bc0a-de84de8ec01a" providerId="ADAL" clId="{58536D34-E4E0-400F-9029-2204521AA67F}" dt="2022-08-07T17:58:10.571" v="122" actId="478"/>
          <ac:picMkLst>
            <pc:docMk/>
            <pc:sldMk cId="924461734" sldId="300"/>
            <ac:picMk id="5" creationId="{FA0D9D96-E636-F00F-ABCF-FB7570D005D4}"/>
          </ac:picMkLst>
        </pc:picChg>
        <pc:picChg chg="add del mod">
          <ac:chgData name="Sabah Akhtar" userId="1c357625-e33f-447b-bc0a-de84de8ec01a" providerId="ADAL" clId="{58536D34-E4E0-400F-9029-2204521AA67F}" dt="2022-08-12T10:57:10.573" v="179"/>
          <ac:picMkLst>
            <pc:docMk/>
            <pc:sldMk cId="924461734" sldId="300"/>
            <ac:picMk id="6" creationId="{F3B463A0-C744-5D11-343C-71A820B8B01A}"/>
          </ac:picMkLst>
        </pc:picChg>
        <pc:picChg chg="add mod modCrop">
          <ac:chgData name="Sabah Akhtar" userId="1c357625-e33f-447b-bc0a-de84de8ec01a" providerId="ADAL" clId="{58536D34-E4E0-400F-9029-2204521AA67F}" dt="2022-08-07T17:58:27.755" v="126" actId="1076"/>
          <ac:picMkLst>
            <pc:docMk/>
            <pc:sldMk cId="924461734" sldId="300"/>
            <ac:picMk id="7" creationId="{DD47AB0F-D75E-4A0B-59DF-0E479DE8F8B6}"/>
          </ac:picMkLst>
        </pc:picChg>
        <pc:picChg chg="add del mod">
          <ac:chgData name="Sabah Akhtar" userId="1c357625-e33f-447b-bc0a-de84de8ec01a" providerId="ADAL" clId="{58536D34-E4E0-400F-9029-2204521AA67F}" dt="2022-08-12T10:57:08.290" v="173"/>
          <ac:picMkLst>
            <pc:docMk/>
            <pc:sldMk cId="924461734" sldId="300"/>
            <ac:picMk id="9" creationId="{107817F6-7A79-4D38-F0A5-1D32C3E1536E}"/>
          </ac:picMkLst>
        </pc:picChg>
        <pc:picChg chg="add del mod">
          <ac:chgData name="Sabah Akhtar" userId="1c357625-e33f-447b-bc0a-de84de8ec01a" providerId="ADAL" clId="{58536D34-E4E0-400F-9029-2204521AA67F}" dt="2022-08-12T10:57:06.705" v="169"/>
          <ac:picMkLst>
            <pc:docMk/>
            <pc:sldMk cId="924461734" sldId="300"/>
            <ac:picMk id="11" creationId="{6DC410FD-C8E5-626C-FF8D-32E4943CC8C8}"/>
          </ac:picMkLst>
        </pc:picChg>
        <pc:picChg chg="add mod">
          <ac:chgData name="Sabah Akhtar" userId="1c357625-e33f-447b-bc0a-de84de8ec01a" providerId="ADAL" clId="{58536D34-E4E0-400F-9029-2204521AA67F}" dt="2022-08-12T10:57:32.999" v="186" actId="1076"/>
          <ac:picMkLst>
            <pc:docMk/>
            <pc:sldMk cId="924461734" sldId="300"/>
            <ac:picMk id="15" creationId="{4B1BD94B-341E-879D-2715-76DED7995525}"/>
          </ac:picMkLst>
        </pc:picChg>
        <pc:picChg chg="add mod">
          <ac:chgData name="Sabah Akhtar" userId="1c357625-e33f-447b-bc0a-de84de8ec01a" providerId="ADAL" clId="{58536D34-E4E0-400F-9029-2204521AA67F}" dt="2022-08-12T10:57:32.999" v="186" actId="1076"/>
          <ac:picMkLst>
            <pc:docMk/>
            <pc:sldMk cId="924461734" sldId="300"/>
            <ac:picMk id="16" creationId="{8D5A35AE-15BF-E749-B120-7902E36E0DDE}"/>
          </ac:picMkLst>
        </pc:picChg>
        <pc:picChg chg="add mod">
          <ac:chgData name="Sabah Akhtar" userId="1c357625-e33f-447b-bc0a-de84de8ec01a" providerId="ADAL" clId="{58536D34-E4E0-400F-9029-2204521AA67F}" dt="2022-08-12T10:57:32.999" v="186" actId="1076"/>
          <ac:picMkLst>
            <pc:docMk/>
            <pc:sldMk cId="924461734" sldId="300"/>
            <ac:picMk id="17" creationId="{B611CA98-34D4-77B0-26AA-3D339CED3210}"/>
          </ac:picMkLst>
        </pc:picChg>
        <pc:picChg chg="add mod">
          <ac:chgData name="Sabah Akhtar" userId="1c357625-e33f-447b-bc0a-de84de8ec01a" providerId="ADAL" clId="{58536D34-E4E0-400F-9029-2204521AA67F}" dt="2022-08-12T10:57:32.999" v="186" actId="1076"/>
          <ac:picMkLst>
            <pc:docMk/>
            <pc:sldMk cId="924461734" sldId="300"/>
            <ac:picMk id="18" creationId="{F319309C-B205-2CF2-4522-17E9403AF1E2}"/>
          </ac:picMkLst>
        </pc:picChg>
        <pc:picChg chg="add mod">
          <ac:chgData name="Sabah Akhtar" userId="1c357625-e33f-447b-bc0a-de84de8ec01a" providerId="ADAL" clId="{58536D34-E4E0-400F-9029-2204521AA67F}" dt="2022-08-12T10:57:32.999" v="186" actId="1076"/>
          <ac:picMkLst>
            <pc:docMk/>
            <pc:sldMk cId="924461734" sldId="300"/>
            <ac:picMk id="19" creationId="{1AF404E1-6C9F-CB68-C263-675673C8D4E9}"/>
          </ac:picMkLst>
        </pc:picChg>
        <pc:picChg chg="mod">
          <ac:chgData name="Sabah Akhtar" userId="1c357625-e33f-447b-bc0a-de84de8ec01a" providerId="ADAL" clId="{58536D34-E4E0-400F-9029-2204521AA67F}" dt="2022-07-30T11:28:15.268" v="70" actId="1582"/>
          <ac:picMkLst>
            <pc:docMk/>
            <pc:sldMk cId="924461734" sldId="300"/>
            <ac:picMk id="50" creationId="{90C2D27A-7D94-497F-85D9-419CC358A0B4}"/>
          </ac:picMkLst>
        </pc:picChg>
        <pc:picChg chg="mod">
          <ac:chgData name="Sabah Akhtar" userId="1c357625-e33f-447b-bc0a-de84de8ec01a" providerId="ADAL" clId="{58536D34-E4E0-400F-9029-2204521AA67F}" dt="2022-07-30T11:32:04.043" v="90"/>
          <ac:picMkLst>
            <pc:docMk/>
            <pc:sldMk cId="924461734" sldId="300"/>
            <ac:picMk id="52" creationId="{2E18EAC9-2BBC-41DE-8AC1-045EF7935CE4}"/>
          </ac:picMkLst>
        </pc:picChg>
        <pc:cxnChg chg="mod">
          <ac:chgData name="Sabah Akhtar" userId="1c357625-e33f-447b-bc0a-de84de8ec01a" providerId="ADAL" clId="{58536D34-E4E0-400F-9029-2204521AA67F}" dt="2022-07-30T11:26:21.648" v="49"/>
          <ac:cxnSpMkLst>
            <pc:docMk/>
            <pc:sldMk cId="924461734" sldId="300"/>
            <ac:cxnSpMk id="22" creationId="{ED1C7858-0025-730F-5B32-48EA0EE57347}"/>
          </ac:cxnSpMkLst>
        </pc:cxnChg>
        <pc:cxnChg chg="del topLvl">
          <ac:chgData name="Sabah Akhtar" userId="1c357625-e33f-447b-bc0a-de84de8ec01a" providerId="ADAL" clId="{58536D34-E4E0-400F-9029-2204521AA67F}" dt="2022-07-30T11:26:43.391" v="53" actId="478"/>
          <ac:cxnSpMkLst>
            <pc:docMk/>
            <pc:sldMk cId="924461734" sldId="300"/>
            <ac:cxnSpMk id="48" creationId="{5E48AC4D-ACA6-427B-894A-4553CC0E18F8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EDB44DD-547E-466A-A4EA-01E018AB3588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462C562-8516-492F-B2CF-5B96EF6D51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035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3888BD-13DB-405A-BCF4-6471E8C0B2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43F8E7-34DA-49EC-B6A0-ADD9DD3A43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1E877E-149D-4248-8FBE-1D22008A0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5C7FE2-5945-4C13-B9E4-F70A0EEF6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6B1080-47FA-4398-8EEB-D006FF466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104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D7EDA-F99C-480B-8198-34BECABC89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07D1E8-567C-41BE-8C45-A75449AFF2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CBB55D-97A9-4A39-92C6-8DB21A298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F1DB6-E3C1-4591-BC7E-A37FCA9C9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C9F465-DB94-46B0-9CAF-BDEE01699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396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92F453-9EC6-4622-BC72-6C57A2D8E0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DE4CB4-2302-42F0-94D4-86BE5A118D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1B9039-EBC2-4CF8-AD94-C3614F376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FD0C2B-78B9-473F-AA4D-2461AB4F6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5A324D-F3DD-40C7-9CAE-C6F1C39E6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732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658E90-0477-417B-92FD-A2D95EEE3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6464D-E7D2-4378-96A0-0976A29602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31877F-A21F-4A78-8EBA-A6F5ECBD0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37A900-2D8A-4C97-A53F-F437D2494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E6EA7A-308C-4267-877A-F092A230C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113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8A1440-2A87-445C-AB98-C1EB57EBD4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54B48B-36AB-40E1-BA9B-38F04B6876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612CCA-1A8C-4E2A-AED5-248BBA591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3FE5CA-33DA-4501-96A5-C5CDD46DC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9029E-952B-48FE-8970-7AF6F4A7E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333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E1F195-9757-444E-96F9-BBCF1E1A9F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317B9F-F9BB-4814-B9F8-DF59651FE6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4FF2BE-593D-4643-8BF6-47E552E795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5D5E82-5F9B-47F2-B93C-908E0EC60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4D2EDD-53C0-4943-BB85-D21F0F2B3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786121-6A94-46DF-8265-9F6513785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705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9CD53-2D96-4E29-8A4C-6BAE4EC0A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96E823-F9EF-4A38-8A36-4143DC3037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BF0460-5B87-4E6B-AF3B-CF4636EF67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1CA44E-938B-4B35-8DF4-7B1612CB4B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54CA7E-036F-441B-B735-87B960F245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AF0DCC-DF72-4883-B4EB-2E662EE0A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E8D5AE-0475-4230-9265-954D39822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65200B-09ED-4D2D-AD6E-357E9568F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040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02558-B53F-4F78-B8E8-95F95ECB2C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75948A-616B-487E-BD05-9F867F1C5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0A548F-916E-47BD-9FEF-617BF37F3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DFDD78-E2FF-45E5-9248-B411EFADB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01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EFBDCC-2876-4EFB-9A22-6D91F11C9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1D605E-0803-463E-946A-FB6577C0F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0C8675-5AA4-411D-9A55-48FB17DDE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584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CCE45-D7F6-4158-85F2-664E1E3467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A05E92-937C-4FFA-B6A1-06178EE678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E5FC06-67BA-45CA-8230-EBC5EAEDD2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5399EA-6378-476E-9CCC-CB7C6977B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6D6D04-08EC-4628-96CC-A206329FA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0BC0E6-C8CD-4C66-83A7-977A866EA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945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45A15B-68EC-4AF0-A76E-BC219E850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8673F0-73C7-4338-8B89-2A5CD023DD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E67715-86EB-49AB-99F6-448B1015C4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A16DA4-55A8-4BAF-82ED-B4AFC6113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0407DB-8E83-4BC9-9199-4FB53B4F7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00CB7F-B755-436D-B437-88468C435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055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6AE3AD-C5C8-42DB-82B3-665E427E23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59BF84-26B9-42B1-A89F-ABE5AA6595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F754BC-33CC-4C04-830B-AD6C446729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AE17D-EAAF-4A84-95CB-8940DCAEDB07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D9293D-40BC-4C18-991D-59C7F97D19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6F0C4B-D342-41C0-A9EE-759D92332D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4B242-BEFB-4C7D-89B3-58C658DF10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12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1621E2DB-65D7-49EE-AA3B-94F6140F4611}"/>
              </a:ext>
            </a:extLst>
          </p:cNvPr>
          <p:cNvSpPr txBox="1"/>
          <p:nvPr/>
        </p:nvSpPr>
        <p:spPr>
          <a:xfrm>
            <a:off x="9686394" y="83807"/>
            <a:ext cx="2579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D1353B6-47FE-4210-6405-28515BD88C94}"/>
              </a:ext>
            </a:extLst>
          </p:cNvPr>
          <p:cNvSpPr txBox="1"/>
          <p:nvPr/>
        </p:nvSpPr>
        <p:spPr>
          <a:xfrm>
            <a:off x="274214" y="3296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2AC9CFC-64C0-4208-9AF1-7457CA073696}"/>
              </a:ext>
            </a:extLst>
          </p:cNvPr>
          <p:cNvGrpSpPr/>
          <p:nvPr/>
        </p:nvGrpSpPr>
        <p:grpSpPr>
          <a:xfrm>
            <a:off x="4608850" y="2979897"/>
            <a:ext cx="3212565" cy="1897304"/>
            <a:chOff x="7366581" y="1299811"/>
            <a:chExt cx="3212565" cy="1897304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9D11B39-283A-4F68-B8A0-FAA66D5147F9}"/>
                </a:ext>
              </a:extLst>
            </p:cNvPr>
            <p:cNvGrpSpPr/>
            <p:nvPr/>
          </p:nvGrpSpPr>
          <p:grpSpPr>
            <a:xfrm>
              <a:off x="7408932" y="1361557"/>
              <a:ext cx="3170214" cy="1835558"/>
              <a:chOff x="7408932" y="1361557"/>
              <a:chExt cx="3170214" cy="1835558"/>
            </a:xfrm>
          </p:grpSpPr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6762CF59-E5F7-4346-9238-726492E5747C}"/>
                  </a:ext>
                </a:extLst>
              </p:cNvPr>
              <p:cNvGrpSpPr/>
              <p:nvPr/>
            </p:nvGrpSpPr>
            <p:grpSpPr>
              <a:xfrm>
                <a:off x="8133469" y="1987710"/>
                <a:ext cx="2162795" cy="1209405"/>
                <a:chOff x="1092094" y="5112375"/>
                <a:chExt cx="1815870" cy="1004335"/>
              </a:xfrm>
            </p:grpSpPr>
            <p:pic>
              <p:nvPicPr>
                <p:cNvPr id="50" name="Picture 49">
                  <a:extLst>
                    <a:ext uri="{FF2B5EF4-FFF2-40B4-BE49-F238E27FC236}">
                      <a16:creationId xmlns:a16="http://schemas.microsoft.com/office/drawing/2014/main" id="{90C2D27A-7D94-497F-85D9-419CC358A0B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092094" y="5602107"/>
                  <a:ext cx="1815870" cy="261696"/>
                </a:xfrm>
                <a:prstGeom prst="rect">
                  <a:avLst/>
                </a:prstGeom>
                <a:ln w="28575">
                  <a:solidFill>
                    <a:schemeClr val="tx1"/>
                  </a:solidFill>
                </a:ln>
              </p:spPr>
            </p:pic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FCFF4B41-8708-4400-B3E2-C36C7948BDF1}"/>
                    </a:ext>
                  </a:extLst>
                </p:cNvPr>
                <p:cNvSpPr txBox="1"/>
                <p:nvPr/>
              </p:nvSpPr>
              <p:spPr>
                <a:xfrm>
                  <a:off x="1405238" y="5886680"/>
                  <a:ext cx="1384921" cy="2300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t: anti-HSP60</a:t>
                  </a:r>
                </a:p>
              </p:txBody>
            </p:sp>
            <p:pic>
              <p:nvPicPr>
                <p:cNvPr id="52" name="Picture 51">
                  <a:extLst>
                    <a:ext uri="{FF2B5EF4-FFF2-40B4-BE49-F238E27FC236}">
                      <a16:creationId xmlns:a16="http://schemas.microsoft.com/office/drawing/2014/main" id="{2E18EAC9-2BBC-41DE-8AC1-045EF7935C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92094" y="5112375"/>
                  <a:ext cx="1799421" cy="259395"/>
                </a:xfrm>
                <a:prstGeom prst="rect">
                  <a:avLst/>
                </a:prstGeom>
                <a:ln w="28575">
                  <a:solidFill>
                    <a:schemeClr val="tx1"/>
                  </a:solidFill>
                </a:ln>
              </p:spPr>
            </p:pic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9FAEB026-269D-4B2D-9340-ABB962B1B3F8}"/>
                    </a:ext>
                  </a:extLst>
                </p:cNvPr>
                <p:cNvSpPr txBox="1"/>
                <p:nvPr/>
              </p:nvSpPr>
              <p:spPr>
                <a:xfrm>
                  <a:off x="1477181" y="5387851"/>
                  <a:ext cx="1241035" cy="2300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lot: anti-SHP-1</a:t>
                  </a:r>
                </a:p>
              </p:txBody>
            </p:sp>
          </p:grp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B30CCFE6-F38C-966C-FD24-F96B06BA52FC}"/>
                  </a:ext>
                </a:extLst>
              </p:cNvPr>
              <p:cNvGrpSpPr/>
              <p:nvPr/>
            </p:nvGrpSpPr>
            <p:grpSpPr>
              <a:xfrm>
                <a:off x="7408932" y="1361557"/>
                <a:ext cx="3170214" cy="598279"/>
                <a:chOff x="5520542" y="1402636"/>
                <a:chExt cx="2878731" cy="685083"/>
              </a:xfrm>
            </p:grpSpPr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7C939D84-D8AB-6977-0974-FC462D4C0D2C}"/>
                    </a:ext>
                  </a:extLst>
                </p:cNvPr>
                <p:cNvSpPr txBox="1"/>
                <p:nvPr/>
              </p:nvSpPr>
              <p:spPr>
                <a:xfrm>
                  <a:off x="5520542" y="1770529"/>
                  <a:ext cx="2878731" cy="3171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S (</a:t>
                  </a:r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µ</a:t>
                  </a: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)     0        5      10      25      50</a:t>
                  </a:r>
                </a:p>
              </p:txBody>
            </p: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ED1C7858-0025-730F-5B32-48EA0EE57347}"/>
                    </a:ext>
                  </a:extLst>
                </p:cNvPr>
                <p:cNvCxnSpPr/>
                <p:nvPr/>
              </p:nvCxnSpPr>
              <p:spPr>
                <a:xfrm>
                  <a:off x="6169567" y="1689139"/>
                  <a:ext cx="2002409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EF19C357-40B4-EB7C-3F9B-4D30F603E747}"/>
                    </a:ext>
                  </a:extLst>
                </p:cNvPr>
                <p:cNvSpPr txBox="1"/>
                <p:nvPr/>
              </p:nvSpPr>
              <p:spPr>
                <a:xfrm>
                  <a:off x="6906389" y="1402636"/>
                  <a:ext cx="499568" cy="3171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266</a:t>
                  </a:r>
                </a:p>
              </p:txBody>
            </p:sp>
          </p:grp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55BF694-1923-5250-B44A-8A3FC0E3AE37}"/>
                </a:ext>
              </a:extLst>
            </p:cNvPr>
            <p:cNvSpPr txBox="1"/>
            <p:nvPr/>
          </p:nvSpPr>
          <p:spPr>
            <a:xfrm>
              <a:off x="7366581" y="129981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6C5D2C2F-565F-443A-9D02-F837BE2C2625}"/>
              </a:ext>
            </a:extLst>
          </p:cNvPr>
          <p:cNvGrpSpPr/>
          <p:nvPr/>
        </p:nvGrpSpPr>
        <p:grpSpPr>
          <a:xfrm>
            <a:off x="5289616" y="1059360"/>
            <a:ext cx="6259992" cy="1440733"/>
            <a:chOff x="4897535" y="1416806"/>
            <a:chExt cx="7210109" cy="1440733"/>
          </a:xfrm>
        </p:grpSpPr>
        <p:sp>
          <p:nvSpPr>
            <p:cNvPr id="13" name="Text Box 23">
              <a:extLst>
                <a:ext uri="{FF2B5EF4-FFF2-40B4-BE49-F238E27FC236}">
                  <a16:creationId xmlns:a16="http://schemas.microsoft.com/office/drawing/2014/main" id="{35A3D724-1A3B-4E74-A98A-392E3AF9DD11}"/>
                </a:ext>
              </a:extLst>
            </p:cNvPr>
            <p:cNvSpPr txBox="1"/>
            <p:nvPr/>
          </p:nvSpPr>
          <p:spPr>
            <a:xfrm rot="16200000">
              <a:off x="11467077" y="2165989"/>
              <a:ext cx="1010785" cy="198569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PMI 8226</a:t>
              </a:r>
              <a:endParaRPr lang="en-US" sz="1200" b="1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" name="Text Box 24">
              <a:extLst>
                <a:ext uri="{FF2B5EF4-FFF2-40B4-BE49-F238E27FC236}">
                  <a16:creationId xmlns:a16="http://schemas.microsoft.com/office/drawing/2014/main" id="{EE04B4FE-831B-FFA6-0924-5F7D549B5274}"/>
                </a:ext>
              </a:extLst>
            </p:cNvPr>
            <p:cNvSpPr txBox="1"/>
            <p:nvPr/>
          </p:nvSpPr>
          <p:spPr>
            <a:xfrm>
              <a:off x="4897535" y="1416806"/>
              <a:ext cx="7210109" cy="249919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GS (µM)           0                        5                     10                     25                     50                                  </a:t>
              </a:r>
            </a:p>
          </p:txBody>
        </p:sp>
        <p:pic>
          <p:nvPicPr>
            <p:cNvPr id="15" name="Picture 14" descr="Background pattern&#10;&#10;Description automatically generated">
              <a:extLst>
                <a:ext uri="{FF2B5EF4-FFF2-40B4-BE49-F238E27FC236}">
                  <a16:creationId xmlns:a16="http://schemas.microsoft.com/office/drawing/2014/main" id="{4B1BD94B-341E-879D-2715-76DED799552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14588" y="1673011"/>
              <a:ext cx="1258596" cy="1184527"/>
            </a:xfrm>
            <a:prstGeom prst="rect">
              <a:avLst/>
            </a:prstGeom>
          </p:spPr>
        </p:pic>
        <p:pic>
          <p:nvPicPr>
            <p:cNvPr id="16" name="Picture 15" descr="Background pattern&#10;&#10;Description automatically generated">
              <a:extLst>
                <a:ext uri="{FF2B5EF4-FFF2-40B4-BE49-F238E27FC236}">
                  <a16:creationId xmlns:a16="http://schemas.microsoft.com/office/drawing/2014/main" id="{8D5A35AE-15BF-E749-B120-7902E36E0DD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1453" y="1673012"/>
              <a:ext cx="1258596" cy="1184527"/>
            </a:xfrm>
            <a:prstGeom prst="rect">
              <a:avLst/>
            </a:prstGeom>
          </p:spPr>
        </p:pic>
        <p:pic>
          <p:nvPicPr>
            <p:cNvPr id="17" name="Picture 16" descr="Background pattern&#10;&#10;Description automatically generated">
              <a:extLst>
                <a:ext uri="{FF2B5EF4-FFF2-40B4-BE49-F238E27FC236}">
                  <a16:creationId xmlns:a16="http://schemas.microsoft.com/office/drawing/2014/main" id="{B611CA98-34D4-77B0-26AA-3D339CED321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8319" y="1673012"/>
              <a:ext cx="1258596" cy="1184527"/>
            </a:xfrm>
            <a:prstGeom prst="rect">
              <a:avLst/>
            </a:prstGeom>
          </p:spPr>
        </p:pic>
        <p:pic>
          <p:nvPicPr>
            <p:cNvPr id="18" name="Picture 17" descr="Background pattern&#10;&#10;Description automatically generated">
              <a:extLst>
                <a:ext uri="{FF2B5EF4-FFF2-40B4-BE49-F238E27FC236}">
                  <a16:creationId xmlns:a16="http://schemas.microsoft.com/office/drawing/2014/main" id="{F319309C-B205-2CF2-4522-17E9403AF1E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65184" y="1673011"/>
              <a:ext cx="1258596" cy="1184527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1AF404E1-6C9F-CB68-C263-675673C8D4E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82050" y="1673011"/>
              <a:ext cx="1258596" cy="1184527"/>
            </a:xfrm>
            <a:prstGeom prst="rect">
              <a:avLst/>
            </a:prstGeom>
          </p:spPr>
        </p:pic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D616AE4A-B5FC-B89D-D074-29C86DC8454B}"/>
              </a:ext>
            </a:extLst>
          </p:cNvPr>
          <p:cNvSpPr txBox="1"/>
          <p:nvPr/>
        </p:nvSpPr>
        <p:spPr>
          <a:xfrm>
            <a:off x="5015437" y="329625"/>
            <a:ext cx="281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D47AB0F-D75E-4A0B-59DF-0E479DE8F8B6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5483" y="253084"/>
            <a:ext cx="3823367" cy="296882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72352A5-1BAA-4F12-9A30-01AD3A8BC6AB}"/>
              </a:ext>
            </a:extLst>
          </p:cNvPr>
          <p:cNvSpPr/>
          <p:nvPr/>
        </p:nvSpPr>
        <p:spPr>
          <a:xfrm>
            <a:off x="449903" y="5077185"/>
            <a:ext cx="11277207" cy="13460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</a:t>
            </a:r>
            <a:r>
              <a:rPr lang="en-GB" sz="1400" b="1">
                <a:latin typeface="Arial" panose="020B0604020202020204" pitchFamily="34" charset="0"/>
                <a:ea typeface="Times New Roman" panose="02020603050405020304" pitchFamily="18" charset="0"/>
              </a:rPr>
              <a:t>Figure S3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. (</a:t>
            </a: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)</a:t>
            </a: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Graphical representation of live and dead analysis for figure 1D. The graph displays mean ± SD where n=3 and **p</a:t>
            </a:r>
            <a:r>
              <a:rPr lang="en-GB" sz="1400">
                <a:latin typeface="Arial" panose="020B0604020202020204" pitchFamily="34" charset="0"/>
                <a:ea typeface="Times New Roman" panose="02020603050405020304" pitchFamily="18" charset="0"/>
              </a:rPr>
              <a:t>&lt;0.01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. (</a:t>
            </a: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)</a:t>
            </a: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The viability of RPMI 8226 cells was evaluated using a live/dead cytotoxicity kit at GS concentrations of 5, 10, 25, and 50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µM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. Green denotes live cells, while red denotes non-viable cells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Scale bar, 200 </a:t>
            </a:r>
            <a:r>
              <a:rPr lang="en-GB" sz="1400" dirty="0" err="1">
                <a:latin typeface="Arial" panose="020B060402020202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μm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).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C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) Involvement of PTPs in GS-induced downregulation of STAT3. Total proteins were extracted from U266 cells, resolved using SDS-PAGE, and probed against SHP-1 and HSP60. 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4461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67</TotalTime>
  <Words>148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ab Khan</dc:creator>
  <cp:lastModifiedBy>MDPI</cp:lastModifiedBy>
  <cp:revision>105</cp:revision>
  <cp:lastPrinted>2022-04-21T11:11:58Z</cp:lastPrinted>
  <dcterms:created xsi:type="dcterms:W3CDTF">2021-08-20T06:19:53Z</dcterms:created>
  <dcterms:modified xsi:type="dcterms:W3CDTF">2022-11-18T07:08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1-08-23T07:38:38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1da757f8-cae0-42fc-bdc1-a0bac48ea637</vt:lpwstr>
  </property>
  <property fmtid="{D5CDD505-2E9C-101B-9397-08002B2CF9AE}" pid="8" name="MSIP_Label_573f5887-035d-4765-8d10-97aaac8deb4a_ContentBits">
    <vt:lpwstr>0</vt:lpwstr>
  </property>
</Properties>
</file>